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1811" r:id="rId2"/>
  </p:sldIdLst>
  <p:sldSz cx="6492875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0042" autoAdjust="0"/>
    <p:restoredTop sz="94660"/>
  </p:normalViewPr>
  <p:slideViewPr>
    <p:cSldViewPr snapToGrid="0">
      <p:cViewPr varScale="1">
        <p:scale>
          <a:sx n="80" d="100"/>
          <a:sy n="80" d="100"/>
        </p:scale>
        <p:origin x="313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02EFE9-E17E-48A4-BD8A-CA79ACF7271C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3625" y="1143000"/>
            <a:ext cx="21907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0229D6-103D-4C95-91C8-A567FA2A88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0895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966" y="1496484"/>
            <a:ext cx="5518944" cy="3183467"/>
          </a:xfrm>
        </p:spPr>
        <p:txBody>
          <a:bodyPr anchor="b"/>
          <a:lstStyle>
            <a:lvl1pPr algn="ctr">
              <a:defRPr sz="42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1610" y="4802717"/>
            <a:ext cx="4869656" cy="2207683"/>
          </a:xfrm>
        </p:spPr>
        <p:txBody>
          <a:bodyPr/>
          <a:lstStyle>
            <a:lvl1pPr marL="0" indent="0" algn="ctr">
              <a:buNone/>
              <a:defRPr sz="1704"/>
            </a:lvl1pPr>
            <a:lvl2pPr marL="324658" indent="0" algn="ctr">
              <a:buNone/>
              <a:defRPr sz="1420"/>
            </a:lvl2pPr>
            <a:lvl3pPr marL="649315" indent="0" algn="ctr">
              <a:buNone/>
              <a:defRPr sz="1278"/>
            </a:lvl3pPr>
            <a:lvl4pPr marL="973973" indent="0" algn="ctr">
              <a:buNone/>
              <a:defRPr sz="1136"/>
            </a:lvl4pPr>
            <a:lvl5pPr marL="1298631" indent="0" algn="ctr">
              <a:buNone/>
              <a:defRPr sz="1136"/>
            </a:lvl5pPr>
            <a:lvl6pPr marL="1623289" indent="0" algn="ctr">
              <a:buNone/>
              <a:defRPr sz="1136"/>
            </a:lvl6pPr>
            <a:lvl7pPr marL="1947946" indent="0" algn="ctr">
              <a:buNone/>
              <a:defRPr sz="1136"/>
            </a:lvl7pPr>
            <a:lvl8pPr marL="2272604" indent="0" algn="ctr">
              <a:buNone/>
              <a:defRPr sz="1136"/>
            </a:lvl8pPr>
            <a:lvl9pPr marL="2597262" indent="0" algn="ctr">
              <a:buNone/>
              <a:defRPr sz="113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400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8471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46464" y="486834"/>
            <a:ext cx="140002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6385" y="486834"/>
            <a:ext cx="4118918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155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462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3004" y="2279653"/>
            <a:ext cx="5600105" cy="3803649"/>
          </a:xfrm>
        </p:spPr>
        <p:txBody>
          <a:bodyPr anchor="b"/>
          <a:lstStyle>
            <a:lvl1pPr>
              <a:defRPr sz="42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3004" y="6119286"/>
            <a:ext cx="5600105" cy="2000249"/>
          </a:xfrm>
        </p:spPr>
        <p:txBody>
          <a:bodyPr/>
          <a:lstStyle>
            <a:lvl1pPr marL="0" indent="0">
              <a:buNone/>
              <a:defRPr sz="1704">
                <a:solidFill>
                  <a:schemeClr val="tx1">
                    <a:tint val="82000"/>
                  </a:schemeClr>
                </a:solidFill>
              </a:defRPr>
            </a:lvl1pPr>
            <a:lvl2pPr marL="324658" indent="0">
              <a:buNone/>
              <a:defRPr sz="1420">
                <a:solidFill>
                  <a:schemeClr val="tx1">
                    <a:tint val="82000"/>
                  </a:schemeClr>
                </a:solidFill>
              </a:defRPr>
            </a:lvl2pPr>
            <a:lvl3pPr marL="649315" indent="0">
              <a:buNone/>
              <a:defRPr sz="1278">
                <a:solidFill>
                  <a:schemeClr val="tx1">
                    <a:tint val="82000"/>
                  </a:schemeClr>
                </a:solidFill>
              </a:defRPr>
            </a:lvl3pPr>
            <a:lvl4pPr marL="973973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4pPr>
            <a:lvl5pPr marL="1298631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5pPr>
            <a:lvl6pPr marL="1623289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6pPr>
            <a:lvl7pPr marL="1947946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7pPr>
            <a:lvl8pPr marL="2272604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8pPr>
            <a:lvl9pPr marL="2597262" indent="0">
              <a:buNone/>
              <a:defRPr sz="1136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104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6385" y="2434167"/>
            <a:ext cx="2759472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7018" y="2434167"/>
            <a:ext cx="2759472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765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486836"/>
            <a:ext cx="560010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7232" y="2241551"/>
            <a:ext cx="2746790" cy="1098549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658" indent="0">
              <a:buNone/>
              <a:defRPr sz="1420" b="1"/>
            </a:lvl2pPr>
            <a:lvl3pPr marL="649315" indent="0">
              <a:buNone/>
              <a:defRPr sz="1278" b="1"/>
            </a:lvl3pPr>
            <a:lvl4pPr marL="973973" indent="0">
              <a:buNone/>
              <a:defRPr sz="1136" b="1"/>
            </a:lvl4pPr>
            <a:lvl5pPr marL="1298631" indent="0">
              <a:buNone/>
              <a:defRPr sz="1136" b="1"/>
            </a:lvl5pPr>
            <a:lvl6pPr marL="1623289" indent="0">
              <a:buNone/>
              <a:defRPr sz="1136" b="1"/>
            </a:lvl6pPr>
            <a:lvl7pPr marL="1947946" indent="0">
              <a:buNone/>
              <a:defRPr sz="1136" b="1"/>
            </a:lvl7pPr>
            <a:lvl8pPr marL="2272604" indent="0">
              <a:buNone/>
              <a:defRPr sz="1136" b="1"/>
            </a:lvl8pPr>
            <a:lvl9pPr marL="2597262" indent="0">
              <a:buNone/>
              <a:defRPr sz="11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7232" y="3340100"/>
            <a:ext cx="2746790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7018" y="2241551"/>
            <a:ext cx="2760318" cy="1098549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658" indent="0">
              <a:buNone/>
              <a:defRPr sz="1420" b="1"/>
            </a:lvl2pPr>
            <a:lvl3pPr marL="649315" indent="0">
              <a:buNone/>
              <a:defRPr sz="1278" b="1"/>
            </a:lvl3pPr>
            <a:lvl4pPr marL="973973" indent="0">
              <a:buNone/>
              <a:defRPr sz="1136" b="1"/>
            </a:lvl4pPr>
            <a:lvl5pPr marL="1298631" indent="0">
              <a:buNone/>
              <a:defRPr sz="1136" b="1"/>
            </a:lvl5pPr>
            <a:lvl6pPr marL="1623289" indent="0">
              <a:buNone/>
              <a:defRPr sz="1136" b="1"/>
            </a:lvl6pPr>
            <a:lvl7pPr marL="1947946" indent="0">
              <a:buNone/>
              <a:defRPr sz="1136" b="1"/>
            </a:lvl7pPr>
            <a:lvl8pPr marL="2272604" indent="0">
              <a:buNone/>
              <a:defRPr sz="1136" b="1"/>
            </a:lvl8pPr>
            <a:lvl9pPr marL="2597262" indent="0">
              <a:buNone/>
              <a:defRPr sz="11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7018" y="3340100"/>
            <a:ext cx="276031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638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130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942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609600"/>
            <a:ext cx="2094121" cy="2133600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60318" y="1316569"/>
            <a:ext cx="3287018" cy="6498167"/>
          </a:xfrm>
        </p:spPr>
        <p:txBody>
          <a:bodyPr/>
          <a:lstStyle>
            <a:lvl1pPr>
              <a:defRPr sz="2272"/>
            </a:lvl1pPr>
            <a:lvl2pPr>
              <a:defRPr sz="1988"/>
            </a:lvl2pPr>
            <a:lvl3pPr>
              <a:defRPr sz="1704"/>
            </a:lvl3pPr>
            <a:lvl4pPr>
              <a:defRPr sz="1420"/>
            </a:lvl4pPr>
            <a:lvl5pPr>
              <a:defRPr sz="1420"/>
            </a:lvl5pPr>
            <a:lvl6pPr>
              <a:defRPr sz="1420"/>
            </a:lvl6pPr>
            <a:lvl7pPr>
              <a:defRPr sz="1420"/>
            </a:lvl7pPr>
            <a:lvl8pPr>
              <a:defRPr sz="1420"/>
            </a:lvl8pPr>
            <a:lvl9pPr>
              <a:defRPr sz="14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231" y="2743200"/>
            <a:ext cx="2094121" cy="5082117"/>
          </a:xfrm>
        </p:spPr>
        <p:txBody>
          <a:bodyPr/>
          <a:lstStyle>
            <a:lvl1pPr marL="0" indent="0">
              <a:buNone/>
              <a:defRPr sz="1136"/>
            </a:lvl1pPr>
            <a:lvl2pPr marL="324658" indent="0">
              <a:buNone/>
              <a:defRPr sz="994"/>
            </a:lvl2pPr>
            <a:lvl3pPr marL="649315" indent="0">
              <a:buNone/>
              <a:defRPr sz="852"/>
            </a:lvl3pPr>
            <a:lvl4pPr marL="973973" indent="0">
              <a:buNone/>
              <a:defRPr sz="710"/>
            </a:lvl4pPr>
            <a:lvl5pPr marL="1298631" indent="0">
              <a:buNone/>
              <a:defRPr sz="710"/>
            </a:lvl5pPr>
            <a:lvl6pPr marL="1623289" indent="0">
              <a:buNone/>
              <a:defRPr sz="710"/>
            </a:lvl6pPr>
            <a:lvl7pPr marL="1947946" indent="0">
              <a:buNone/>
              <a:defRPr sz="710"/>
            </a:lvl7pPr>
            <a:lvl8pPr marL="2272604" indent="0">
              <a:buNone/>
              <a:defRPr sz="710"/>
            </a:lvl8pPr>
            <a:lvl9pPr marL="2597262" indent="0">
              <a:buNone/>
              <a:defRPr sz="7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202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609600"/>
            <a:ext cx="2094121" cy="2133600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60318" y="1316569"/>
            <a:ext cx="3287018" cy="6498167"/>
          </a:xfrm>
        </p:spPr>
        <p:txBody>
          <a:bodyPr anchor="t"/>
          <a:lstStyle>
            <a:lvl1pPr marL="0" indent="0">
              <a:buNone/>
              <a:defRPr sz="2272"/>
            </a:lvl1pPr>
            <a:lvl2pPr marL="324658" indent="0">
              <a:buNone/>
              <a:defRPr sz="1988"/>
            </a:lvl2pPr>
            <a:lvl3pPr marL="649315" indent="0">
              <a:buNone/>
              <a:defRPr sz="1704"/>
            </a:lvl3pPr>
            <a:lvl4pPr marL="973973" indent="0">
              <a:buNone/>
              <a:defRPr sz="1420"/>
            </a:lvl4pPr>
            <a:lvl5pPr marL="1298631" indent="0">
              <a:buNone/>
              <a:defRPr sz="1420"/>
            </a:lvl5pPr>
            <a:lvl6pPr marL="1623289" indent="0">
              <a:buNone/>
              <a:defRPr sz="1420"/>
            </a:lvl6pPr>
            <a:lvl7pPr marL="1947946" indent="0">
              <a:buNone/>
              <a:defRPr sz="1420"/>
            </a:lvl7pPr>
            <a:lvl8pPr marL="2272604" indent="0">
              <a:buNone/>
              <a:defRPr sz="1420"/>
            </a:lvl8pPr>
            <a:lvl9pPr marL="2597262" indent="0">
              <a:buNone/>
              <a:defRPr sz="142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231" y="2743200"/>
            <a:ext cx="2094121" cy="5082117"/>
          </a:xfrm>
        </p:spPr>
        <p:txBody>
          <a:bodyPr/>
          <a:lstStyle>
            <a:lvl1pPr marL="0" indent="0">
              <a:buNone/>
              <a:defRPr sz="1136"/>
            </a:lvl1pPr>
            <a:lvl2pPr marL="324658" indent="0">
              <a:buNone/>
              <a:defRPr sz="994"/>
            </a:lvl2pPr>
            <a:lvl3pPr marL="649315" indent="0">
              <a:buNone/>
              <a:defRPr sz="852"/>
            </a:lvl3pPr>
            <a:lvl4pPr marL="973973" indent="0">
              <a:buNone/>
              <a:defRPr sz="710"/>
            </a:lvl4pPr>
            <a:lvl5pPr marL="1298631" indent="0">
              <a:buNone/>
              <a:defRPr sz="710"/>
            </a:lvl5pPr>
            <a:lvl6pPr marL="1623289" indent="0">
              <a:buNone/>
              <a:defRPr sz="710"/>
            </a:lvl6pPr>
            <a:lvl7pPr marL="1947946" indent="0">
              <a:buNone/>
              <a:defRPr sz="710"/>
            </a:lvl7pPr>
            <a:lvl8pPr marL="2272604" indent="0">
              <a:buNone/>
              <a:defRPr sz="710"/>
            </a:lvl8pPr>
            <a:lvl9pPr marL="2597262" indent="0">
              <a:buNone/>
              <a:defRPr sz="7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533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6385" y="486836"/>
            <a:ext cx="560010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85" y="2434167"/>
            <a:ext cx="560010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6385" y="8475136"/>
            <a:ext cx="1460897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AC090B4-FD4E-4CC8-9641-3820951A025D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50765" y="8475136"/>
            <a:ext cx="219134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5593" y="8475136"/>
            <a:ext cx="1460897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4FEAB4B-9412-4893-89A1-ADF821604C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140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9315" rtl="0" eaLnBrk="1" latinLnBrk="0" hangingPunct="1">
        <a:lnSpc>
          <a:spcPct val="90000"/>
        </a:lnSpc>
        <a:spcBef>
          <a:spcPct val="0"/>
        </a:spcBef>
        <a:buNone/>
        <a:defRPr sz="312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329" indent="-162329" algn="l" defTabSz="649315" rtl="0" eaLnBrk="1" latinLnBrk="0" hangingPunct="1">
        <a:lnSpc>
          <a:spcPct val="90000"/>
        </a:lnSpc>
        <a:spcBef>
          <a:spcPts val="710"/>
        </a:spcBef>
        <a:buFont typeface="Arial" panose="020B0604020202020204" pitchFamily="34" charset="0"/>
        <a:buChar char="•"/>
        <a:defRPr sz="1988" kern="1200">
          <a:solidFill>
            <a:schemeClr val="tx1"/>
          </a:solidFill>
          <a:latin typeface="+mn-lt"/>
          <a:ea typeface="+mn-ea"/>
          <a:cs typeface="+mn-cs"/>
        </a:defRPr>
      </a:lvl1pPr>
      <a:lvl2pPr marL="48698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704" kern="1200">
          <a:solidFill>
            <a:schemeClr val="tx1"/>
          </a:solidFill>
          <a:latin typeface="+mn-lt"/>
          <a:ea typeface="+mn-ea"/>
          <a:cs typeface="+mn-cs"/>
        </a:defRPr>
      </a:lvl2pPr>
      <a:lvl3pPr marL="811644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420" kern="1200">
          <a:solidFill>
            <a:schemeClr val="tx1"/>
          </a:solidFill>
          <a:latin typeface="+mn-lt"/>
          <a:ea typeface="+mn-ea"/>
          <a:cs typeface="+mn-cs"/>
        </a:defRPr>
      </a:lvl3pPr>
      <a:lvl4pPr marL="1136302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460960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78561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2110275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434933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759591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1pPr>
      <a:lvl2pPr marL="324658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2pPr>
      <a:lvl3pPr marL="649315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3pPr>
      <a:lvl4pPr marL="973973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298631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623289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1947946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272604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597262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DF1D43CB-B90A-13EA-D6AB-FF08C64D8C05}"/>
              </a:ext>
            </a:extLst>
          </p:cNvPr>
          <p:cNvGrpSpPr/>
          <p:nvPr/>
        </p:nvGrpSpPr>
        <p:grpSpPr>
          <a:xfrm>
            <a:off x="176132" y="431088"/>
            <a:ext cx="2926925" cy="1719026"/>
            <a:chOff x="919858" y="971941"/>
            <a:chExt cx="4218848" cy="2477791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0BE754AE-B392-9044-AF68-4AB8A25486A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19858" y="1285821"/>
              <a:ext cx="4218848" cy="2163911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13FBDFE2-834D-78EC-9A95-ABA2F4437141}"/>
                </a:ext>
              </a:extLst>
            </p:cNvPr>
            <p:cNvSpPr txBox="1"/>
            <p:nvPr/>
          </p:nvSpPr>
          <p:spPr>
            <a:xfrm>
              <a:off x="2000588" y="971941"/>
              <a:ext cx="2704609" cy="354901"/>
            </a:xfrm>
            <a:prstGeom prst="rect">
              <a:avLst/>
            </a:prstGeom>
            <a:noFill/>
          </p:spPr>
          <p:txBody>
            <a:bodyPr wrap="square" lIns="0" tIns="0" rIns="0" bIns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M2 in QNS1065</a:t>
              </a:r>
              <a:endParaRPr lang="en-US" sz="1600" dirty="0"/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2A257381-002C-583B-28AD-C2A48B3C4F59}"/>
              </a:ext>
            </a:extLst>
          </p:cNvPr>
          <p:cNvGrpSpPr/>
          <p:nvPr/>
        </p:nvGrpSpPr>
        <p:grpSpPr>
          <a:xfrm>
            <a:off x="2970962" y="426558"/>
            <a:ext cx="2854423" cy="1723555"/>
            <a:chOff x="919858" y="3461943"/>
            <a:chExt cx="4147590" cy="2504394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50D039D-6AE7-BED8-8DEC-9D69804FD27F}"/>
                </a:ext>
              </a:extLst>
            </p:cNvPr>
            <p:cNvSpPr txBox="1"/>
            <p:nvPr/>
          </p:nvSpPr>
          <p:spPr>
            <a:xfrm>
              <a:off x="2201260" y="3461943"/>
              <a:ext cx="2222420" cy="357769"/>
            </a:xfrm>
            <a:prstGeom prst="rect">
              <a:avLst/>
            </a:prstGeom>
            <a:noFill/>
          </p:spPr>
          <p:txBody>
            <a:bodyPr wrap="square" lIns="0" tIns="0" rIns="0" bIns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M2 in QNS1070</a:t>
              </a:r>
              <a:endParaRPr lang="en-US" sz="1600" dirty="0"/>
            </a:p>
          </p:txBody>
        </p: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2DFE8E11-8EF0-0FEE-CB1A-B6B5CD58091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19858" y="3781341"/>
              <a:ext cx="4147590" cy="2184996"/>
            </a:xfrm>
            <a:prstGeom prst="rect">
              <a:avLst/>
            </a:prstGeom>
          </p:spPr>
        </p:pic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71EA5CE1-F022-8A4C-2D5D-61876FC7A47F}"/>
              </a:ext>
            </a:extLst>
          </p:cNvPr>
          <p:cNvGrpSpPr/>
          <p:nvPr/>
        </p:nvGrpSpPr>
        <p:grpSpPr>
          <a:xfrm>
            <a:off x="1411705" y="2150115"/>
            <a:ext cx="3043807" cy="1714610"/>
            <a:chOff x="854968" y="5993787"/>
            <a:chExt cx="4592352" cy="2586923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5618577A-F8E4-8C75-4328-79A6155EAB7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54968" y="6389924"/>
              <a:ext cx="4491477" cy="2190786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56FF7D3-AE96-C0A7-C913-91184E77854F}"/>
                </a:ext>
              </a:extLst>
            </p:cNvPr>
            <p:cNvSpPr txBox="1"/>
            <p:nvPr/>
          </p:nvSpPr>
          <p:spPr>
            <a:xfrm>
              <a:off x="2250267" y="5993787"/>
              <a:ext cx="3197053" cy="371487"/>
            </a:xfrm>
            <a:prstGeom prst="rect">
              <a:avLst/>
            </a:prstGeom>
            <a:noFill/>
          </p:spPr>
          <p:txBody>
            <a:bodyPr wrap="square" lIns="0" tIns="0" rIns="0" bIns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M2 in QNS 871</a:t>
              </a:r>
              <a:endParaRPr lang="en-US" sz="1600" dirty="0"/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BE5F6192-F916-2F5F-7730-53113D4C7DE5}"/>
              </a:ext>
            </a:extLst>
          </p:cNvPr>
          <p:cNvGrpSpPr/>
          <p:nvPr/>
        </p:nvGrpSpPr>
        <p:grpSpPr>
          <a:xfrm>
            <a:off x="1156518" y="4007081"/>
            <a:ext cx="3298994" cy="1876617"/>
            <a:chOff x="526411" y="1064040"/>
            <a:chExt cx="5518572" cy="3139213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3FBDFE2-834D-78EC-9A95-ABA2F4437141}"/>
                </a:ext>
              </a:extLst>
            </p:cNvPr>
            <p:cNvSpPr txBox="1"/>
            <p:nvPr/>
          </p:nvSpPr>
          <p:spPr>
            <a:xfrm>
              <a:off x="2176223" y="1064040"/>
              <a:ext cx="2824571" cy="411880"/>
            </a:xfrm>
            <a:prstGeom prst="rect">
              <a:avLst/>
            </a:prstGeom>
            <a:noFill/>
          </p:spPr>
          <p:txBody>
            <a:bodyPr wrap="square" lIns="0" tIns="0" rIns="0" bIns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TAM in QNS1065</a:t>
              </a:r>
              <a:endParaRPr lang="en-US" sz="1600" dirty="0"/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AD16327-D1A4-09AE-D57F-9DADDD4A995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26411" y="1340429"/>
              <a:ext cx="5518572" cy="2862824"/>
            </a:xfrm>
            <a:prstGeom prst="rect">
              <a:avLst/>
            </a:prstGeom>
          </p:spPr>
        </p:pic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490C1792-E1FF-FB04-AB8B-E4BC7D4C2854}"/>
              </a:ext>
            </a:extLst>
          </p:cNvPr>
          <p:cNvGrpSpPr/>
          <p:nvPr/>
        </p:nvGrpSpPr>
        <p:grpSpPr>
          <a:xfrm>
            <a:off x="1156518" y="5765860"/>
            <a:ext cx="3732786" cy="2136812"/>
            <a:chOff x="487150" y="4414257"/>
            <a:chExt cx="5518573" cy="3159075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50D039D-6AE7-BED8-8DEC-9D69804FD27F}"/>
                </a:ext>
              </a:extLst>
            </p:cNvPr>
            <p:cNvSpPr txBox="1"/>
            <p:nvPr/>
          </p:nvSpPr>
          <p:spPr>
            <a:xfrm>
              <a:off x="2043196" y="4414257"/>
              <a:ext cx="2668740" cy="364015"/>
            </a:xfrm>
            <a:prstGeom prst="rect">
              <a:avLst/>
            </a:prstGeom>
            <a:noFill/>
          </p:spPr>
          <p:txBody>
            <a:bodyPr wrap="square" lIns="0" tIns="0" rIns="0" bIns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TAM in QNS1070</a:t>
              </a:r>
              <a:endParaRPr lang="en-US" sz="1600" dirty="0"/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15E31CE4-FAED-DFB8-8B39-BA418521A07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87150" y="4694528"/>
              <a:ext cx="5518573" cy="2878804"/>
            </a:xfrm>
            <a:prstGeom prst="rect">
              <a:avLst/>
            </a:prstGeom>
          </p:spPr>
        </p:pic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801E2A84-4098-5460-C53D-EC81148CB55B}"/>
              </a:ext>
            </a:extLst>
          </p:cNvPr>
          <p:cNvSpPr txBox="1"/>
          <p:nvPr/>
        </p:nvSpPr>
        <p:spPr>
          <a:xfrm>
            <a:off x="0" y="7935209"/>
            <a:ext cx="6492875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6. Immunophenotypic Characterization and PD-L1 Expression in M2 Macrophages and TAMs from GBM Patients</a:t>
            </a:r>
            <a:r>
              <a:rPr lang="en-US" sz="1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Macrophages were identified using CD163 and CD209 as surface markers to define a double-positive population, followed by analysis of PD-L1 expression within this subset. High PD-L1 expression was observed in M2 macrophages from samples QNS1065, QNS1070, and QNS871, as well as in TAMs from QNS1065 and QNS1070.</a:t>
            </a:r>
          </a:p>
        </p:txBody>
      </p:sp>
    </p:spTree>
    <p:extLst>
      <p:ext uri="{BB962C8B-B14F-4D97-AF65-F5344CB8AC3E}">
        <p14:creationId xmlns:p14="http://schemas.microsoft.com/office/powerpoint/2010/main" val="3285495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95</TotalTime>
  <Words>87</Words>
  <Application>Microsoft Office PowerPoint</Application>
  <PresentationFormat>Custom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Ulloa Navas, Maria J., Ph.D., M.S.</dc:creator>
  <cp:lastModifiedBy>Ulloa Navas, Maria J., Ph.D., M.S.</cp:lastModifiedBy>
  <cp:revision>64</cp:revision>
  <dcterms:created xsi:type="dcterms:W3CDTF">2024-09-02T16:12:58Z</dcterms:created>
  <dcterms:modified xsi:type="dcterms:W3CDTF">2024-11-22T20:09:20Z</dcterms:modified>
</cp:coreProperties>
</file>